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983413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E2788-6546-46FD-8CFA-0933A670D6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5D963F-A86A-4B31-8B95-8FB207F156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C88AD2-53E6-43B2-8D0A-CA354C451D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52B9C5-6330-4D04-BF95-34E62453AA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99D1A7-6F5E-4712-B366-37154CCBE0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F26AF-BC19-4403-9B13-4C1F8A3506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91409-BF8F-4ADC-94DA-96EE4BCECA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4E47D-8B8E-42BD-B0D2-E998EA310D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327F1-DA78-4B17-A941-964EE82EB8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41AE63-9129-435F-B8CC-C053C302DA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39AA7B-8758-46D5-9A1D-508240656C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2D198-BD64-48F5-A2AB-84FB4DB099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AB3AB8-ADEC-4C87-856F-111C468C5C3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1"/>
          <p:cNvSpPr/>
          <p:nvPr/>
        </p:nvSpPr>
        <p:spPr>
          <a:xfrm>
            <a:off x="152280" y="606600"/>
            <a:ext cx="601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.                                                                                              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8" descr=""/>
          <p:cNvPicPr/>
          <p:nvPr/>
        </p:nvPicPr>
        <p:blipFill>
          <a:blip r:embed="rId1"/>
          <a:srcRect l="4919" t="12500" r="29517" b="8750"/>
          <a:stretch/>
        </p:blipFill>
        <p:spPr>
          <a:xfrm>
            <a:off x="304920" y="1066680"/>
            <a:ext cx="4114800" cy="41911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3" descr=""/>
          <p:cNvPicPr/>
          <p:nvPr/>
        </p:nvPicPr>
        <p:blipFill>
          <a:blip r:embed="rId2"/>
          <a:srcRect l="4919" t="11250" r="26003" b="8750"/>
          <a:stretch/>
        </p:blipFill>
        <p:spPr>
          <a:xfrm>
            <a:off x="4724280" y="990720"/>
            <a:ext cx="4114800" cy="43225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 txBox="1"/>
          <p:nvPr/>
        </p:nvSpPr>
        <p:spPr>
          <a:xfrm>
            <a:off x="457200" y="5867280"/>
            <a:ext cx="8229600" cy="609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74000"/>
          </a:bodyPr>
          <a:p>
            <a:pPr marL="253800" indent="-253800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Figure 3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Alignment of WNV lineages comparing fragment 4 of VIROAF73 (i.) and fragment 11 (ii.) of VIROAF74 against 4 WNV lineages. For the alignment, the dashed line indicates the presence of the same base as the master template WNV lineage 2, which classifies these fragments as WNV lineage 2 phylogenetically (Figure 2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53800" indent="-253800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53800" indent="-253800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6T04:28:08Z</dcterms:created>
  <dc:creator>Wiriya Rutvisuttinunt</dc:creator>
  <dc:description/>
  <dc:language>en-US</dc:language>
  <cp:lastModifiedBy>Wiriya Rutvisuttinunt</cp:lastModifiedBy>
  <dcterms:modified xsi:type="dcterms:W3CDTF">2014-08-05T03:03:25Z</dcterms:modified>
  <cp:revision>231</cp:revision>
  <dc:subject/>
  <dc:title>WNV</dc:title>
</cp:coreProperties>
</file>